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10316F-F842-427E-ADDF-B20D65B4BB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5AB7CA-233D-40DD-8AD9-AA131CBFA0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3D388-5286-43BF-9C48-AC2E0544D0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72CC9-CAF1-459C-AA95-3E04F1E6FE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09E853-B800-45F1-B4EB-7F40AA8491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D43DE2-6897-42B5-9975-CA58571CF3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771339-4D62-4EAB-9803-5D77058F2B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DA597-EAEC-42F1-AB62-4F0CE2E68E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45745-EC9A-4206-B3F3-9C7DB6A245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AD1719-598D-4330-9136-ED0E962870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2B65D0-D906-45CD-9131-5D2B63DB8B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A72667-BE06-458B-A5A8-2985C9F65A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555D86A-34DD-42C6-9375-952F2181340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1166760" y="6842160"/>
            <a:ext cx="510372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7: Figure S5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level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NP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aplotypes in young panicle at the panicle initiation stage. (a) Expression level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NP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NP1-6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in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ia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ubpopulation.(b) Expression level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4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6 in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g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bpopulation. (c) Expression level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,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L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3 in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xian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ubpopulation. Error bars indicate SD; Letters are ranked by Duncan’s test at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5.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* denotes significance of Student’ s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est at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&lt; 0.05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352"/>
          <p:cNvSpPr/>
          <p:nvPr/>
        </p:nvSpPr>
        <p:spPr>
          <a:xfrm rot="16200000">
            <a:off x="1272240" y="1379880"/>
            <a:ext cx="182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xpression lev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文本框 39"/>
          <p:cNvSpPr/>
          <p:nvPr/>
        </p:nvSpPr>
        <p:spPr>
          <a:xfrm>
            <a:off x="3565440" y="952560"/>
            <a:ext cx="449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23" descr="C:\Users\Administrator\Desktop\图片4.png"/>
          <p:cNvPicPr/>
          <p:nvPr/>
        </p:nvPicPr>
        <p:blipFill>
          <a:blip r:embed="rId1"/>
          <a:srcRect l="0" t="0" r="0" b="8953"/>
          <a:stretch/>
        </p:blipFill>
        <p:spPr>
          <a:xfrm>
            <a:off x="2246400" y="822240"/>
            <a:ext cx="2097000" cy="2119320"/>
          </a:xfrm>
          <a:prstGeom prst="rect">
            <a:avLst/>
          </a:prstGeom>
          <a:ln w="0">
            <a:noFill/>
          </a:ln>
        </p:spPr>
      </p:pic>
      <p:sp>
        <p:nvSpPr>
          <p:cNvPr id="45" name="矩形 35"/>
          <p:cNvSpPr/>
          <p:nvPr/>
        </p:nvSpPr>
        <p:spPr>
          <a:xfrm>
            <a:off x="2679840" y="2913120"/>
            <a:ext cx="66348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GNP1</a:t>
            </a:r>
            <a:r>
              <a:rPr b="0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矩形 36"/>
          <p:cNvSpPr/>
          <p:nvPr/>
        </p:nvSpPr>
        <p:spPr>
          <a:xfrm>
            <a:off x="3481560" y="2913120"/>
            <a:ext cx="66348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GNP1</a:t>
            </a:r>
            <a:r>
              <a:rPr b="0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30"/>
          <p:cNvSpPr/>
          <p:nvPr/>
        </p:nvSpPr>
        <p:spPr>
          <a:xfrm>
            <a:off x="1469880" y="835200"/>
            <a:ext cx="37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75"/>
          <p:cNvSpPr/>
          <p:nvPr/>
        </p:nvSpPr>
        <p:spPr>
          <a:xfrm>
            <a:off x="3122640" y="312264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Xi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352"/>
          <p:cNvSpPr/>
          <p:nvPr/>
        </p:nvSpPr>
        <p:spPr>
          <a:xfrm rot="16200000">
            <a:off x="-45000" y="4404240"/>
            <a:ext cx="1828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Expression lev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组合 1"/>
          <p:cNvGrpSpPr/>
          <p:nvPr/>
        </p:nvGrpSpPr>
        <p:grpSpPr>
          <a:xfrm>
            <a:off x="3705120" y="3830400"/>
            <a:ext cx="2738520" cy="2723400"/>
            <a:chOff x="3705120" y="3830400"/>
            <a:chExt cx="2738520" cy="2723400"/>
          </a:xfrm>
        </p:grpSpPr>
        <p:pic>
          <p:nvPicPr>
            <p:cNvPr id="51" name="图表 1" descr=""/>
            <p:cNvPicPr/>
            <p:nvPr/>
          </p:nvPicPr>
          <p:blipFill>
            <a:blip r:embed="rId2"/>
            <a:stretch/>
          </p:blipFill>
          <p:spPr>
            <a:xfrm>
              <a:off x="3895560" y="4024080"/>
              <a:ext cx="2548080" cy="2349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矩形 31"/>
            <p:cNvSpPr/>
            <p:nvPr/>
          </p:nvSpPr>
          <p:spPr>
            <a:xfrm>
              <a:off x="4381200" y="6072480"/>
              <a:ext cx="425160" cy="166680"/>
            </a:xfrm>
            <a:prstGeom prst="rect">
              <a:avLst/>
            </a:prstGeom>
            <a:noFill/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矩形 32"/>
            <p:cNvSpPr/>
            <p:nvPr/>
          </p:nvSpPr>
          <p:spPr>
            <a:xfrm>
              <a:off x="4343040" y="6067800"/>
              <a:ext cx="662040" cy="201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d0d0d"/>
                  </a:solidFill>
                  <a:latin typeface="Times New Roman"/>
                  <a:ea typeface="Times New Roman"/>
                </a:rPr>
                <a:t>NAL1</a:t>
              </a:r>
              <a:r>
                <a:rPr b="0" lang="en-US" sz="1000" spc="-1" strike="noStrike">
                  <a:solidFill>
                    <a:srgbClr val="0d0d0d"/>
                  </a:solidFill>
                  <a:latin typeface="Times New Roman"/>
                  <a:ea typeface="Times New Roman"/>
                </a:rPr>
                <a:t>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矩形 33"/>
            <p:cNvSpPr/>
            <p:nvPr/>
          </p:nvSpPr>
          <p:spPr>
            <a:xfrm>
              <a:off x="4967280" y="6067800"/>
              <a:ext cx="663480" cy="201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d0d0d"/>
                  </a:solidFill>
                  <a:latin typeface="Times New Roman"/>
                  <a:ea typeface="Times New Roman"/>
                </a:rPr>
                <a:t>NAL1</a:t>
              </a:r>
              <a:r>
                <a:rPr b="0" lang="en-US" sz="1000" spc="-1" strike="noStrike">
                  <a:solidFill>
                    <a:srgbClr val="0d0d0d"/>
                  </a:solidFill>
                  <a:latin typeface="Times New Roman"/>
                  <a:ea typeface="Times New Roman"/>
                </a:rPr>
                <a:t>-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矩形 34"/>
            <p:cNvSpPr/>
            <p:nvPr/>
          </p:nvSpPr>
          <p:spPr>
            <a:xfrm>
              <a:off x="5607000" y="6067800"/>
              <a:ext cx="663480" cy="201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d0d0d"/>
                  </a:solidFill>
                  <a:latin typeface="Times New Roman"/>
                  <a:ea typeface="Times New Roman"/>
                </a:rPr>
                <a:t>NAL1</a:t>
              </a:r>
              <a:r>
                <a:rPr b="0" lang="en-US" sz="1000" spc="-1" strike="noStrike">
                  <a:solidFill>
                    <a:srgbClr val="0d0d0d"/>
                  </a:solidFill>
                  <a:latin typeface="Times New Roman"/>
                  <a:ea typeface="Times New Roman"/>
                </a:rPr>
                <a:t>-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352"/>
            <p:cNvSpPr/>
            <p:nvPr/>
          </p:nvSpPr>
          <p:spPr>
            <a:xfrm rot="16200000">
              <a:off x="3020400" y="4515120"/>
              <a:ext cx="1828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Expression leve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75"/>
            <p:cNvSpPr/>
            <p:nvPr/>
          </p:nvSpPr>
          <p:spPr>
            <a:xfrm>
              <a:off x="5043600" y="6277320"/>
              <a:ext cx="990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Times New Roman"/>
                </a:rPr>
                <a:t>Xia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TextBox 130"/>
          <p:cNvSpPr/>
          <p:nvPr/>
        </p:nvSpPr>
        <p:spPr>
          <a:xfrm>
            <a:off x="485640" y="3522600"/>
            <a:ext cx="37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30"/>
          <p:cNvSpPr/>
          <p:nvPr/>
        </p:nvSpPr>
        <p:spPr>
          <a:xfrm>
            <a:off x="3381480" y="3508200"/>
            <a:ext cx="36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41"/>
          <p:cNvSpPr/>
          <p:nvPr/>
        </p:nvSpPr>
        <p:spPr>
          <a:xfrm>
            <a:off x="1308240" y="5983200"/>
            <a:ext cx="66348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NAL1</a:t>
            </a:r>
            <a:r>
              <a:rPr b="0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42"/>
          <p:cNvSpPr/>
          <p:nvPr/>
        </p:nvSpPr>
        <p:spPr>
          <a:xfrm>
            <a:off x="2023920" y="5989680"/>
            <a:ext cx="66384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NAL1</a:t>
            </a:r>
            <a:r>
              <a:rPr b="0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矩形 43"/>
          <p:cNvSpPr/>
          <p:nvPr/>
        </p:nvSpPr>
        <p:spPr>
          <a:xfrm>
            <a:off x="2747880" y="5997600"/>
            <a:ext cx="663480" cy="20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NAL1</a:t>
            </a:r>
            <a:r>
              <a:rPr b="0" lang="en-US" sz="1000" spc="-1" strike="noStrike">
                <a:solidFill>
                  <a:srgbClr val="0d0d0d"/>
                </a:solidFill>
                <a:latin typeface="Times New Roman"/>
                <a:ea typeface="Times New Roman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3"/>
          <p:cNvSpPr/>
          <p:nvPr/>
        </p:nvSpPr>
        <p:spPr>
          <a:xfrm>
            <a:off x="1506600" y="3803760"/>
            <a:ext cx="29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28"/>
          <p:cNvSpPr/>
          <p:nvPr/>
        </p:nvSpPr>
        <p:spPr>
          <a:xfrm>
            <a:off x="2954160" y="5359320"/>
            <a:ext cx="297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9"/>
          <p:cNvSpPr/>
          <p:nvPr/>
        </p:nvSpPr>
        <p:spPr>
          <a:xfrm>
            <a:off x="2222640" y="4816440"/>
            <a:ext cx="296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24" descr="C:\Users\Administrator\Desktop\图片5.png"/>
          <p:cNvPicPr/>
          <p:nvPr/>
        </p:nvPicPr>
        <p:blipFill>
          <a:blip r:embed="rId3"/>
          <a:srcRect l="0" t="0" r="0" b="9548"/>
          <a:stretch/>
        </p:blipFill>
        <p:spPr>
          <a:xfrm>
            <a:off x="890640" y="3693960"/>
            <a:ext cx="2712960" cy="2324160"/>
          </a:xfrm>
          <a:prstGeom prst="rect">
            <a:avLst/>
          </a:prstGeom>
          <a:ln w="0">
            <a:noFill/>
          </a:ln>
        </p:spPr>
      </p:pic>
      <p:sp>
        <p:nvSpPr>
          <p:cNvPr id="67" name="TextBox 175"/>
          <p:cNvSpPr/>
          <p:nvPr/>
        </p:nvSpPr>
        <p:spPr>
          <a:xfrm>
            <a:off x="2089080" y="6173640"/>
            <a:ext cx="99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Gen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9T17:55:43Z</dcterms:created>
  <dc:creator>Zhikang Li</dc:creator>
  <dc:description/>
  <dc:language>en-US</dc:language>
  <cp:lastModifiedBy>微软用户</cp:lastModifiedBy>
  <dcterms:modified xsi:type="dcterms:W3CDTF">2020-02-13T05:21:19Z</dcterms:modified>
  <cp:revision>411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822</vt:lpwstr>
  </property>
</Properties>
</file>